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5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BBEE5-2B1C-4A37-9BD7-967E4FE90F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3FC422-D29A-44F2-9C12-5153700256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0F02FE-3336-44A8-A8D9-E211E2774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0F482-EB06-403B-A559-AA10BBE2F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B6F5E-702B-4A78-9003-5B0F8932F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9041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760112-AECE-4084-93D3-E55D93403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A8EDBF-F07A-45F9-8F89-FECA67E6C6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E36CA7-4396-40D9-835C-DFB7E1F2D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A7E11F-4255-44D3-8D07-E2C830604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46BD8-C7CC-4F0C-9BB1-724A46F9B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222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36DB9F-0831-4C53-AF97-82DCA1BE4C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3EF377-491A-46AC-829E-EFDA2D89FB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1B93A6-8E64-4C7A-950E-3A4DFBEE5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8DC510-31FC-4B11-9E54-E8E3619E2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0F37FB-B716-43E9-A6AA-2FC01B44B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381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4FBF3-2582-4090-90AF-493D94279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0BE3F-BA5C-4DD7-B283-F05199666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317931-1702-488B-8BAE-16A21CCF9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AC8835-8C63-42B8-8A40-E56156DD2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36FF3F-C008-4A26-9C8D-8A8A8CBAF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9344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ABA36-1BC7-4AB7-A077-9A2FBEA5A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F792C-8F7A-45B4-A11F-C4F29872EF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6C1021-27DC-4E6A-9256-E049A19DB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3829A-BBE2-44A0-8858-77C943B3F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E4D6A4-FB27-4D19-9742-0DFA834E9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709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EF97A-BCA0-4820-8B2B-8AD3382C3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68DF08-C46A-4134-8634-9438766B6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56B7B8-E8C8-4468-80B7-8D3D08F5BC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D2611F-25E7-4687-8A34-050D5C902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DA94F6-08F6-4C71-B903-CD84CB5A3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F7730E-34DB-4F56-8E5E-5493B6389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349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D5599-CBB0-4C76-9780-5BA6D16C0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051115-F8EA-4EF4-928F-23CAC0B138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7AED51-2517-42AB-BEDE-882143B02E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AF3CAF-5F32-4AC3-BFD8-678BAAA9C3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E7A090-8750-4B6A-ADB0-A5B0DC5497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9A2ABF-6ECA-4A0B-A5CD-DB85F710D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4DAADB-6EB5-42E4-AAAE-2B559F876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6FBA86-DBE7-4826-857C-3F3CADCEC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733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87581-B0EF-49D1-9DF0-96C8510C0F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B96A98-40D8-4088-91AC-85F0C7611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70B335-7674-4DD0-948E-EB7B3692A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F87A6A-E77A-430E-9FE6-DF2D4242A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72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054BB7-62D0-4341-B78C-28BBA316B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8507EF-DC5A-4903-918D-5E16878BF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FC70D2-BB59-4674-ACBD-139FBA790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7680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F66C2-0B53-473F-B2DD-0F23A06F6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CD4B4C-19C2-4D35-B636-9980845ABC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AB7CB9-AFB6-48AD-8854-4D0496E184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8F80B0-C0C8-4A88-A777-C45FF06EA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B73022-DB49-4FCC-AFA8-09D2CCFA4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F25A66-C23F-4407-900F-D1656EC88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385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EA728-F434-4A24-A7F9-FD8ECB310F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494135-AE7D-4F2C-918F-D0DF29E1A2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0F5F8A-4F22-4AE0-BCA3-C037D30376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91D0B-541B-4C6D-96D9-74058FFEC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D028BF-D683-4F5C-B619-B9BDA7E32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6C1986-8722-489D-8E34-60F9BB538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627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A9DFB2-CF92-40BA-AD1A-88EF7E452D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6533A1-5383-48B3-9C85-1B9A679C8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0C0C60-FDC5-428A-881D-6C754DB9A9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3705B-58EA-41FD-9670-28869157C19E}" type="datetimeFigureOut">
              <a:rPr lang="en-GB" smtClean="0"/>
              <a:t>30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93CBA-4D85-4D94-808E-B4BA9D6493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393653-1BFE-44D4-9DDA-68C2EE653A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23AD2-34DC-407C-8F51-AAD43F17FC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2183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B20D367-BA5A-49A0-B193-EE4555A5BAD6}"/>
              </a:ext>
            </a:extLst>
          </p:cNvPr>
          <p:cNvSpPr txBox="1"/>
          <p:nvPr/>
        </p:nvSpPr>
        <p:spPr>
          <a:xfrm>
            <a:off x="633463" y="5024629"/>
            <a:ext cx="109541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Figure 6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hasing of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KlCAB2p::LUC+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KlGPT2p::LUC+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changes throughout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GB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axiflora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leaf development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Three biological replicates of a stable transgenic of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. </a:t>
            </a:r>
            <a:r>
              <a:rPr lang="en-GB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laxiflora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iploid OBG expressing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lCAB2p::LUC+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and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lGPT2p::LUC+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were imaged under LL conditions at 15˚C for 7-d. Mean LUC+ expression from ZT0 – ZT24 is represented here via rose diagrams for each LP, scale is consistent within each genotype, at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maximum of 200 normalised units of bioluminescence for KlCAB2p::LUC+ and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400 units for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lGPT2p::LUC+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8BFFBFB-E6D1-44AB-B51E-0338F411E5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294" y="1147869"/>
            <a:ext cx="5142270" cy="353820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7D540EA-D5C0-46BE-B92B-E2D7796D4CB0}"/>
              </a:ext>
            </a:extLst>
          </p:cNvPr>
          <p:cNvSpPr txBox="1"/>
          <p:nvPr/>
        </p:nvSpPr>
        <p:spPr>
          <a:xfrm>
            <a:off x="728294" y="809315"/>
            <a:ext cx="7685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GB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KlCAB2p::LUC+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B</a:t>
            </a:r>
            <a:r>
              <a:rPr lang="en-GB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. KlGPT2p::LUC+        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56F18EE-1FF9-4D29-8775-4A79D814DA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0564" y="1187041"/>
            <a:ext cx="5142270" cy="35382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5292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6</TotalTime>
  <Words>12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Pritchard</dc:creator>
  <cp:lastModifiedBy>Hartwell, James</cp:lastModifiedBy>
  <cp:revision>3</cp:revision>
  <cp:lastPrinted>2026-03-31T14:06:32Z</cp:lastPrinted>
  <dcterms:created xsi:type="dcterms:W3CDTF">2026-03-30T16:30:14Z</dcterms:created>
  <dcterms:modified xsi:type="dcterms:W3CDTF">2026-03-31T17:18:03Z</dcterms:modified>
</cp:coreProperties>
</file>